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54078-4988-4CCE-962C-F2995836D9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56D94-A21A-43B7-BC92-9969DDFA9C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8E141-0A13-4FBA-B528-4E4C15F410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D3E29-D256-4A73-A4C5-83EEF81D42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2635E-8822-4DA4-8CB6-8AA2E07A59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4F869-82F9-4BD8-98BD-F5A5237477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0FFDA-7602-4A2F-B901-7D68CA5F97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9083A-23DA-43AA-843B-E6806EC9B8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CF82F-A75B-4B81-AFDD-08451F727D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DBE5F-FB7A-4147-9410-A80AB0AEE0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EEC70-B942-4226-99A7-36309D4999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56A8B-708F-47EB-B72B-D4E3AA70EF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E99B2C-5A97-4F8F-A33A-5F54431717F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762120" y="609480"/>
            <a:ext cx="4778280" cy="68580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>
            <a:off x="76320" y="685800"/>
            <a:ext cx="533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76320" y="2319480"/>
            <a:ext cx="533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76320" y="4911840"/>
            <a:ext cx="533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5943600" y="4351320"/>
            <a:ext cx="533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D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3" descr=""/>
          <p:cNvPicPr/>
          <p:nvPr/>
        </p:nvPicPr>
        <p:blipFill>
          <a:blip r:embed="rId2"/>
          <a:stretch/>
        </p:blipFill>
        <p:spPr>
          <a:xfrm>
            <a:off x="762120" y="2395440"/>
            <a:ext cx="4800600" cy="12621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5" descr=""/>
          <p:cNvPicPr/>
          <p:nvPr/>
        </p:nvPicPr>
        <p:blipFill>
          <a:blip r:embed="rId3"/>
          <a:stretch/>
        </p:blipFill>
        <p:spPr>
          <a:xfrm>
            <a:off x="6053040" y="4888080"/>
            <a:ext cx="3014640" cy="142848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6"/>
          <p:cNvSpPr/>
          <p:nvPr/>
        </p:nvSpPr>
        <p:spPr>
          <a:xfrm>
            <a:off x="6127560" y="6335640"/>
            <a:ext cx="21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A12308G (+ 12307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685800" y="4724280"/>
          <a:ext cx="4876920" cy="1812960"/>
        </p:xfrm>
        <a:graphic>
          <a:graphicData uri="http://schemas.openxmlformats.org/drawingml/2006/table">
            <a:tbl>
              <a:tblPr/>
              <a:tblGrid>
                <a:gridCol w="1033560"/>
                <a:gridCol w="887400"/>
                <a:gridCol w="1255680"/>
                <a:gridCol w="1700280"/>
              </a:tblGrid>
              <a:tr h="5202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Sample I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SN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Original Scor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Discordant Call Typ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LE_C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T220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Extr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LE_C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12307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.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Extr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LE_C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T16362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2.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iss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LE_C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12307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.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Extr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LE_C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12307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0.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Extr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2T13:38:27Z</dcterms:created>
  <dc:creator>Carol Sin</dc:creator>
  <dc:description/>
  <dc:language>en-US</dc:language>
  <cp:lastModifiedBy>Carol Sin</cp:lastModifiedBy>
  <dcterms:modified xsi:type="dcterms:W3CDTF">2011-10-02T14:45:13Z</dcterms:modified>
  <cp:revision>6</cp:revision>
  <dc:subject/>
  <dc:title>Additional File 1.</dc:title>
</cp:coreProperties>
</file>